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media/image10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9410E-B954-4F10-8A0E-562A87BD49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7CD398-5432-4013-94BD-F9980D3256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0FC8D-11F5-4ACF-9BC8-D43221877F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5D42A-6302-4E09-95E8-5A457E2ADC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0F9CF-90FA-4B3A-8095-EE48B58605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2EDFF-44C0-46F4-9AFD-B453FE20E3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E5E77-289D-468D-9144-44FCB2D21A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1EB8B-47AA-46CC-B216-0678858CA5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A83F0-E261-4B19-94F5-52E8414A04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60BF8-456D-46DB-B154-E020570DB5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61309-1AA0-4771-A160-4E10AFF3F1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087D6F-04CC-4936-B352-CC34F800E4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900" spc="-1" strike="noStrike">
                <a:solidFill>
                  <a:srgbClr val="898989"/>
                </a:solidFill>
                <a:latin typeface="Calibri"/>
                <a:ea typeface="新細明體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TW" sz="900" spc="-1" strike="noStrike">
                <a:solidFill>
                  <a:srgbClr val="898989"/>
                </a:solidFill>
                <a:latin typeface="Calibri"/>
                <a:ea typeface="新細明體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900" spc="-1" strike="noStrike">
                <a:solidFill>
                  <a:srgbClr val="898989"/>
                </a:solidFill>
                <a:latin typeface="Calibri"/>
                <a:ea typeface="新細明體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24C5BAA-0D11-4ACD-AA75-63632F067228}" type="slidenum">
              <a:rPr b="0" lang="zh-TW" sz="900" spc="-1" strike="noStrike">
                <a:solidFill>
                  <a:srgbClr val="898989"/>
                </a:solidFill>
                <a:latin typeface="Calibri"/>
                <a:ea typeface="新細明體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9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群組 1"/>
          <p:cNvGrpSpPr/>
          <p:nvPr/>
        </p:nvGrpSpPr>
        <p:grpSpPr>
          <a:xfrm>
            <a:off x="1201680" y="453960"/>
            <a:ext cx="3921120" cy="7531200"/>
            <a:chOff x="1201680" y="453960"/>
            <a:chExt cx="3921120" cy="7531200"/>
          </a:xfrm>
        </p:grpSpPr>
        <p:sp>
          <p:nvSpPr>
            <p:cNvPr id="42" name="文字方塊 33"/>
            <p:cNvSpPr/>
            <p:nvPr/>
          </p:nvSpPr>
          <p:spPr>
            <a:xfrm>
              <a:off x="1982160" y="453960"/>
              <a:ext cx="82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DelA-F1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文字方塊 34"/>
            <p:cNvSpPr/>
            <p:nvPr/>
          </p:nvSpPr>
          <p:spPr>
            <a:xfrm>
              <a:off x="3659760" y="453960"/>
              <a:ext cx="93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DelA-F16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文字方塊 35"/>
            <p:cNvSpPr/>
            <p:nvPr/>
          </p:nvSpPr>
          <p:spPr>
            <a:xfrm rot="16200000">
              <a:off x="618120" y="1495080"/>
              <a:ext cx="144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Neg. control/</a:t>
              </a:r>
              <a:r>
                <a:rPr b="0" lang="en-US" sz="1200" spc="-1" strike="noStrike">
                  <a:solidFill>
                    <a:srgbClr val="0f06ba"/>
                  </a:solidFill>
                  <a:latin typeface="Arial"/>
                  <a:ea typeface="新細明體"/>
                </a:rPr>
                <a:t> DAP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文字方塊 36"/>
            <p:cNvSpPr/>
            <p:nvPr/>
          </p:nvSpPr>
          <p:spPr>
            <a:xfrm rot="16200000">
              <a:off x="1075680" y="3385800"/>
              <a:ext cx="52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新細明體"/>
                </a:rPr>
                <a:t>ZO-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文字方塊 37"/>
            <p:cNvSpPr/>
            <p:nvPr/>
          </p:nvSpPr>
          <p:spPr>
            <a:xfrm rot="16200000">
              <a:off x="995040" y="5175000"/>
              <a:ext cx="68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b050"/>
                  </a:solidFill>
                  <a:latin typeface="Arial"/>
                  <a:ea typeface="新細明體"/>
                </a:rPr>
                <a:t>DUS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文字方塊 38"/>
            <p:cNvSpPr/>
            <p:nvPr/>
          </p:nvSpPr>
          <p:spPr>
            <a:xfrm rot="16200000">
              <a:off x="618840" y="6995880"/>
              <a:ext cx="147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新細明體"/>
                </a:rPr>
                <a:t>ZO-1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/</a:t>
              </a:r>
              <a:r>
                <a:rPr b="0" lang="en-US" sz="1200" spc="-1" strike="noStrike">
                  <a:solidFill>
                    <a:srgbClr val="00b050"/>
                  </a:solidFill>
                  <a:latin typeface="Arial"/>
                  <a:ea typeface="新細明體"/>
                </a:rPr>
                <a:t>DUSP3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/</a:t>
              </a:r>
              <a:r>
                <a:rPr b="0" lang="en-US" sz="1200" spc="-1" strike="noStrike">
                  <a:solidFill>
                    <a:srgbClr val="0f06ba"/>
                  </a:solidFill>
                  <a:latin typeface="Arial"/>
                  <a:ea typeface="新細明體"/>
                </a:rPr>
                <a:t>DAP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8" name="群組 1"/>
            <p:cNvGrpSpPr/>
            <p:nvPr/>
          </p:nvGrpSpPr>
          <p:grpSpPr>
            <a:xfrm>
              <a:off x="1500120" y="730080"/>
              <a:ext cx="3622680" cy="7255080"/>
              <a:chOff x="1500120" y="730080"/>
              <a:chExt cx="3622680" cy="7255080"/>
            </a:xfrm>
          </p:grpSpPr>
          <p:pic>
            <p:nvPicPr>
              <p:cNvPr id="49" name="圖片 6" descr=""/>
              <p:cNvPicPr/>
              <p:nvPr/>
            </p:nvPicPr>
            <p:blipFill>
              <a:blip r:embed="rId1"/>
              <a:stretch/>
            </p:blipFill>
            <p:spPr>
              <a:xfrm>
                <a:off x="3332160" y="730080"/>
                <a:ext cx="1790640" cy="1792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圖片 24" descr=""/>
              <p:cNvPicPr/>
              <p:nvPr/>
            </p:nvPicPr>
            <p:blipFill>
              <a:blip r:embed="rId2"/>
              <a:stretch/>
            </p:blipFill>
            <p:spPr>
              <a:xfrm>
                <a:off x="1500120" y="730080"/>
                <a:ext cx="1790640" cy="1792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圖片 2" descr=""/>
              <p:cNvPicPr/>
              <p:nvPr/>
            </p:nvPicPr>
            <p:blipFill>
              <a:blip r:embed="rId3"/>
              <a:stretch/>
            </p:blipFill>
            <p:spPr>
              <a:xfrm>
                <a:off x="1504800" y="2552400"/>
                <a:ext cx="1782720" cy="1790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圖片 5" descr=""/>
              <p:cNvPicPr/>
              <p:nvPr/>
            </p:nvPicPr>
            <p:blipFill>
              <a:blip r:embed="rId4"/>
              <a:stretch/>
            </p:blipFill>
            <p:spPr>
              <a:xfrm>
                <a:off x="1504800" y="4375080"/>
                <a:ext cx="1782720" cy="1789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圖片 10" descr=""/>
              <p:cNvPicPr/>
              <p:nvPr/>
            </p:nvPicPr>
            <p:blipFill>
              <a:blip r:embed="rId5"/>
              <a:stretch/>
            </p:blipFill>
            <p:spPr>
              <a:xfrm>
                <a:off x="1504800" y="6194520"/>
                <a:ext cx="1782720" cy="1790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圖片 15" descr=""/>
              <p:cNvPicPr/>
              <p:nvPr/>
            </p:nvPicPr>
            <p:blipFill>
              <a:blip r:embed="rId6"/>
              <a:stretch/>
            </p:blipFill>
            <p:spPr>
              <a:xfrm>
                <a:off x="3335400" y="2552400"/>
                <a:ext cx="1782720" cy="1789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5" name="圖片 17" descr=""/>
              <p:cNvPicPr/>
              <p:nvPr/>
            </p:nvPicPr>
            <p:blipFill>
              <a:blip r:embed="rId7"/>
              <a:stretch/>
            </p:blipFill>
            <p:spPr>
              <a:xfrm>
                <a:off x="3335400" y="4373640"/>
                <a:ext cx="1782720" cy="1789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6" name="圖片 19" descr=""/>
              <p:cNvPicPr/>
              <p:nvPr/>
            </p:nvPicPr>
            <p:blipFill>
              <a:blip r:embed="rId8"/>
              <a:stretch/>
            </p:blipFill>
            <p:spPr>
              <a:xfrm>
                <a:off x="3335400" y="6194520"/>
                <a:ext cx="1782720" cy="179064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57" name="文字方塊 20"/>
          <p:cNvSpPr/>
          <p:nvPr/>
        </p:nvSpPr>
        <p:spPr>
          <a:xfrm>
            <a:off x="325440" y="8169120"/>
            <a:ext cx="62056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Supplementary Figure 1. DUSP3-deficient cells have defective tight junction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Confluent DelA-F13 cells (DUSP3+/+) and F16R cells (DUSP3-/-) were subjected to immunofluorescence (IF) staining using anti-ZO-1 (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33-9100)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and anti-DUSP3 (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AP8478a)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antibodies. Negative (Neg.) controls of IF staining were performed in the absence of primary antibodies. DAPI was used for nuclear staining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文字方塊 1"/>
          <p:cNvSpPr/>
          <p:nvPr/>
        </p:nvSpPr>
        <p:spPr>
          <a:xfrm>
            <a:off x="527040" y="7099200"/>
            <a:ext cx="61056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Supplementary Figure 2. DUSP3-deficient cells have different cell cycle distribution pattern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Confluent DelA variant cells were detached by trypsin treatment, washed with phosphate buffer saline twice, fixed in 70% ethanol for 2 days, and then stained with 5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g/ml of  propidium iodide (PI) in the presence of RNaseA (1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g/ml) for 2 hours. The cell cycle distribution patterns were then determined by the standard flow cytometry assa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群組 2"/>
          <p:cNvGrpSpPr/>
          <p:nvPr/>
        </p:nvGrpSpPr>
        <p:grpSpPr>
          <a:xfrm>
            <a:off x="650880" y="2116080"/>
            <a:ext cx="5191200" cy="4746600"/>
            <a:chOff x="650880" y="2116080"/>
            <a:chExt cx="5191200" cy="4746600"/>
          </a:xfrm>
        </p:grpSpPr>
        <p:grpSp>
          <p:nvGrpSpPr>
            <p:cNvPr id="60" name="群組 3"/>
            <p:cNvGrpSpPr/>
            <p:nvPr/>
          </p:nvGrpSpPr>
          <p:grpSpPr>
            <a:xfrm>
              <a:off x="650880" y="2116080"/>
              <a:ext cx="5191200" cy="4530960"/>
              <a:chOff x="650880" y="2116080"/>
              <a:chExt cx="5191200" cy="4530960"/>
            </a:xfrm>
          </p:grpSpPr>
          <p:pic>
            <p:nvPicPr>
              <p:cNvPr id="61" name="Picture 2" descr="C:\Users\GloMax\Desktop\Flow-04212022-2\20220422-Layout-2-Batch.png"/>
              <p:cNvPicPr/>
              <p:nvPr/>
            </p:nvPicPr>
            <p:blipFill>
              <a:blip r:embed="rId1"/>
              <a:srcRect l="0" t="2278" r="0" b="67471"/>
              <a:stretch/>
            </p:blipFill>
            <p:spPr>
              <a:xfrm>
                <a:off x="650880" y="2116080"/>
                <a:ext cx="5191200" cy="1538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2" name="Picture 2" descr="C:\Users\GloMax\Desktop\Flow-04212022-2\20220422-Layout-2-Batch.png"/>
              <p:cNvPicPr/>
              <p:nvPr/>
            </p:nvPicPr>
            <p:blipFill>
              <a:blip r:embed="rId2"/>
              <a:srcRect l="0" t="34804" r="0" b="35395"/>
              <a:stretch/>
            </p:blipFill>
            <p:spPr>
              <a:xfrm>
                <a:off x="650880" y="3592440"/>
                <a:ext cx="5191200" cy="151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" name="Picture 2" descr="C:\Users\GloMax\Desktop\Flow-04212022-2\20220422-Layout-2-Batch.png"/>
              <p:cNvPicPr/>
              <p:nvPr/>
            </p:nvPicPr>
            <p:blipFill>
              <a:blip r:embed="rId3"/>
              <a:srcRect l="0" t="67028" r="0" b="1966"/>
              <a:stretch/>
            </p:blipFill>
            <p:spPr>
              <a:xfrm>
                <a:off x="650880" y="5070600"/>
                <a:ext cx="5191200" cy="1576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文字方塊 1"/>
              <p:cNvSpPr/>
              <p:nvPr/>
            </p:nvSpPr>
            <p:spPr>
              <a:xfrm>
                <a:off x="1763640" y="216468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+/+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文字方塊 5"/>
              <p:cNvSpPr/>
              <p:nvPr/>
            </p:nvSpPr>
            <p:spPr>
              <a:xfrm>
                <a:off x="3427560" y="216612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+/+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文字方塊 6"/>
              <p:cNvSpPr/>
              <p:nvPr/>
            </p:nvSpPr>
            <p:spPr>
              <a:xfrm>
                <a:off x="5091120" y="216468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+/+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文字方塊 7"/>
              <p:cNvSpPr/>
              <p:nvPr/>
            </p:nvSpPr>
            <p:spPr>
              <a:xfrm>
                <a:off x="1713240" y="362808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4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+/−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文字方塊 8"/>
              <p:cNvSpPr/>
              <p:nvPr/>
            </p:nvSpPr>
            <p:spPr>
              <a:xfrm>
                <a:off x="3427560" y="362808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4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+/−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文字方塊 9"/>
              <p:cNvSpPr/>
              <p:nvPr/>
            </p:nvSpPr>
            <p:spPr>
              <a:xfrm>
                <a:off x="5091120" y="360720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5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−/−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文字方塊 10"/>
              <p:cNvSpPr/>
              <p:nvPr/>
            </p:nvSpPr>
            <p:spPr>
              <a:xfrm>
                <a:off x="1740600" y="512100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5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−/−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文字方塊 11"/>
              <p:cNvSpPr/>
              <p:nvPr/>
            </p:nvSpPr>
            <p:spPr>
              <a:xfrm>
                <a:off x="3421800" y="512100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6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−/−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文字方塊 12"/>
              <p:cNvSpPr/>
              <p:nvPr/>
            </p:nvSpPr>
            <p:spPr>
              <a:xfrm>
                <a:off x="5091120" y="5121000"/>
                <a:ext cx="6897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DelA-F16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(Dusp3−/−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文字方塊 2"/>
              <p:cNvSpPr/>
              <p:nvPr/>
            </p:nvSpPr>
            <p:spPr>
              <a:xfrm rot="16200000">
                <a:off x="452880" y="2789280"/>
                <a:ext cx="708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Cell Count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文字方塊 14"/>
              <p:cNvSpPr/>
              <p:nvPr/>
            </p:nvSpPr>
            <p:spPr>
              <a:xfrm rot="16200000">
                <a:off x="447120" y="4133160"/>
                <a:ext cx="708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Cell Count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文字方塊 15"/>
              <p:cNvSpPr/>
              <p:nvPr/>
            </p:nvSpPr>
            <p:spPr>
              <a:xfrm rot="16200000">
                <a:off x="447120" y="5751360"/>
                <a:ext cx="708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新細明體"/>
                  </a:rPr>
                  <a:t>Cell Count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6" name="文字方塊 4"/>
            <p:cNvSpPr/>
            <p:nvPr/>
          </p:nvSpPr>
          <p:spPr>
            <a:xfrm>
              <a:off x="2916720" y="6647040"/>
              <a:ext cx="65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PI stainin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文字方塊 18"/>
            <p:cNvSpPr/>
            <p:nvPr/>
          </p:nvSpPr>
          <p:spPr>
            <a:xfrm>
              <a:off x="1300320" y="6647040"/>
              <a:ext cx="65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PI stainin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文字方塊 19"/>
            <p:cNvSpPr/>
            <p:nvPr/>
          </p:nvSpPr>
          <p:spPr>
            <a:xfrm>
              <a:off x="4634640" y="6647040"/>
              <a:ext cx="659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新細明體"/>
                </a:rPr>
                <a:t>PI stainin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圖片 1" descr=""/>
          <p:cNvPicPr/>
          <p:nvPr/>
        </p:nvPicPr>
        <p:blipFill>
          <a:blip r:embed="rId1"/>
          <a:stretch/>
        </p:blipFill>
        <p:spPr>
          <a:xfrm>
            <a:off x="922320" y="2266920"/>
            <a:ext cx="4759200" cy="4665600"/>
          </a:xfrm>
          <a:prstGeom prst="rect">
            <a:avLst/>
          </a:prstGeom>
          <a:ln w="0">
            <a:noFill/>
          </a:ln>
        </p:spPr>
      </p:pic>
      <p:sp>
        <p:nvSpPr>
          <p:cNvPr id="80" name="文字方塊 2"/>
          <p:cNvSpPr/>
          <p:nvPr/>
        </p:nvSpPr>
        <p:spPr>
          <a:xfrm>
            <a:off x="328680" y="7149960"/>
            <a:ext cx="62071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Supplementary Figure 3. Histological sections of lung tissues from DUSP3+/+ and DUSP3-/- mice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Lung tissues from wild-type and DUSP3-/- mice were harvested, fixed, parafilm-embedded and processed into 4-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dvTT6120e2aa+03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m-thick tissue sections. The sections were subjected to standard hematoxylin and eosin staining. The right panels were the 2-fold magnification of inserts in the left panel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5-15T08:15:06Z</dcterms:created>
  <dc:creator>Yi-Rong Chen</dc:creator>
  <dc:description/>
  <dc:language>en-US</dc:language>
  <cp:lastModifiedBy>Yi-Rong Chen</cp:lastModifiedBy>
  <dcterms:modified xsi:type="dcterms:W3CDTF">2022-05-17T07:06:51Z</dcterms:modified>
  <cp:revision>9</cp:revision>
  <dc:subject/>
  <dc:title>PowerPoint 簡報</dc:title>
</cp:coreProperties>
</file>